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7" r:id="rId2"/>
    <p:sldId id="266" r:id="rId3"/>
    <p:sldId id="269" r:id="rId4"/>
    <p:sldId id="270" r:id="rId5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이영미" initials="이" lastIdx="1" clrIdx="0">
    <p:extLst>
      <p:ext uri="{19B8F6BF-5375-455C-9EA6-DF929625EA0E}">
        <p15:presenceInfo xmlns:p15="http://schemas.microsoft.com/office/powerpoint/2012/main" userId="813c973c5fa40b9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069" autoAdjust="0"/>
    <p:restoredTop sz="94660"/>
  </p:normalViewPr>
  <p:slideViewPr>
    <p:cSldViewPr>
      <p:cViewPr varScale="1">
        <p:scale>
          <a:sx n="110" d="100"/>
          <a:sy n="110" d="100"/>
        </p:scale>
        <p:origin x="1848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lee\Desktop\gravity-core_env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lee\Desktop\gravity-core_env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lee\Desktop\gravity-core_env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lee\Desktop\gravity-core_env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149098805187696"/>
          <c:y val="0.20863799283154122"/>
          <c:w val="0.76145530343749168"/>
          <c:h val="0.73190869380478207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xVal>
            <c:numRef>
              <c:f>Sheet2!$B$2:$B$22</c:f>
              <c:numCache>
                <c:formatCode>0.00_);[Red]\(0.00\)</c:formatCode>
                <c:ptCount val="21"/>
                <c:pt idx="0">
                  <c:v>0.14000000000000001</c:v>
                </c:pt>
                <c:pt idx="1">
                  <c:v>0.13</c:v>
                </c:pt>
                <c:pt idx="2">
                  <c:v>0.12</c:v>
                </c:pt>
                <c:pt idx="3">
                  <c:v>0.11</c:v>
                </c:pt>
                <c:pt idx="4">
                  <c:v>0.1</c:v>
                </c:pt>
                <c:pt idx="5">
                  <c:v>0.08</c:v>
                </c:pt>
                <c:pt idx="6">
                  <c:v>0.06</c:v>
                </c:pt>
                <c:pt idx="7">
                  <c:v>2.9681110754609108E-2</c:v>
                </c:pt>
                <c:pt idx="8">
                  <c:v>0.03</c:v>
                </c:pt>
                <c:pt idx="9">
                  <c:v>0.03</c:v>
                </c:pt>
                <c:pt idx="10">
                  <c:v>0.02</c:v>
                </c:pt>
                <c:pt idx="11">
                  <c:v>0.03</c:v>
                </c:pt>
                <c:pt idx="12">
                  <c:v>0.03</c:v>
                </c:pt>
                <c:pt idx="13">
                  <c:v>0.03</c:v>
                </c:pt>
                <c:pt idx="14">
                  <c:v>0.02</c:v>
                </c:pt>
                <c:pt idx="15">
                  <c:v>0.02</c:v>
                </c:pt>
                <c:pt idx="16">
                  <c:v>3.0057575553655624E-2</c:v>
                </c:pt>
                <c:pt idx="17">
                  <c:v>0.02</c:v>
                </c:pt>
                <c:pt idx="18">
                  <c:v>0.02</c:v>
                </c:pt>
                <c:pt idx="19">
                  <c:v>0.09</c:v>
                </c:pt>
                <c:pt idx="20">
                  <c:v>0.03</c:v>
                </c:pt>
              </c:numCache>
            </c:numRef>
          </c:xVal>
          <c:yVal>
            <c:numRef>
              <c:f>Sheet2!$A$2:$A$22</c:f>
              <c:numCache>
                <c:formatCode>General</c:formatCode>
                <c:ptCount val="21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  <c:pt idx="6">
                  <c:v>120</c:v>
                </c:pt>
                <c:pt idx="7">
                  <c:v>140</c:v>
                </c:pt>
                <c:pt idx="8">
                  <c:v>160</c:v>
                </c:pt>
                <c:pt idx="9">
                  <c:v>180</c:v>
                </c:pt>
                <c:pt idx="10">
                  <c:v>200</c:v>
                </c:pt>
                <c:pt idx="11">
                  <c:v>220</c:v>
                </c:pt>
                <c:pt idx="12">
                  <c:v>240</c:v>
                </c:pt>
                <c:pt idx="13">
                  <c:v>260</c:v>
                </c:pt>
                <c:pt idx="14">
                  <c:v>280</c:v>
                </c:pt>
                <c:pt idx="15">
                  <c:v>300</c:v>
                </c:pt>
                <c:pt idx="16">
                  <c:v>320</c:v>
                </c:pt>
                <c:pt idx="17">
                  <c:v>340</c:v>
                </c:pt>
                <c:pt idx="18">
                  <c:v>360</c:v>
                </c:pt>
                <c:pt idx="19">
                  <c:v>380</c:v>
                </c:pt>
                <c:pt idx="20">
                  <c:v>39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CA3-4FF6-8605-D558CAEE5C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06952"/>
        <c:axId val="6609696"/>
      </c:scatterChart>
      <c:valAx>
        <c:axId val="6606952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_);[Red]\(0.0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609696"/>
        <c:crosses val="autoZero"/>
        <c:crossBetween val="midCat"/>
      </c:valAx>
      <c:valAx>
        <c:axId val="6609696"/>
        <c:scaling>
          <c:orientation val="maxMin"/>
          <c:max val="4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606952"/>
        <c:crosses val="autoZero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xVal>
            <c:numRef>
              <c:f>Sheet2!$E$2:$E$22</c:f>
              <c:numCache>
                <c:formatCode>0.00_);[Red]\(0.00\)</c:formatCode>
                <c:ptCount val="21"/>
                <c:pt idx="0">
                  <c:v>1</c:v>
                </c:pt>
                <c:pt idx="1">
                  <c:v>0.9</c:v>
                </c:pt>
                <c:pt idx="2">
                  <c:v>0.94</c:v>
                </c:pt>
                <c:pt idx="3">
                  <c:v>0.88</c:v>
                </c:pt>
                <c:pt idx="4">
                  <c:v>0.75</c:v>
                </c:pt>
                <c:pt idx="5">
                  <c:v>0.65</c:v>
                </c:pt>
                <c:pt idx="6">
                  <c:v>0.42</c:v>
                </c:pt>
                <c:pt idx="7">
                  <c:v>0.24959540698814392</c:v>
                </c:pt>
                <c:pt idx="8">
                  <c:v>0.28000000000000003</c:v>
                </c:pt>
                <c:pt idx="9">
                  <c:v>0.3</c:v>
                </c:pt>
                <c:pt idx="10">
                  <c:v>0.27</c:v>
                </c:pt>
                <c:pt idx="11">
                  <c:v>0.28999999999999998</c:v>
                </c:pt>
                <c:pt idx="12">
                  <c:v>0.36</c:v>
                </c:pt>
                <c:pt idx="13">
                  <c:v>0.36</c:v>
                </c:pt>
                <c:pt idx="14">
                  <c:v>0.26</c:v>
                </c:pt>
                <c:pt idx="15">
                  <c:v>0.22</c:v>
                </c:pt>
                <c:pt idx="16">
                  <c:v>0.25802345630836487</c:v>
                </c:pt>
                <c:pt idx="17">
                  <c:v>0.21</c:v>
                </c:pt>
                <c:pt idx="18">
                  <c:v>0.25</c:v>
                </c:pt>
                <c:pt idx="19">
                  <c:v>0.83</c:v>
                </c:pt>
                <c:pt idx="20">
                  <c:v>0.27</c:v>
                </c:pt>
              </c:numCache>
            </c:numRef>
          </c:xVal>
          <c:yVal>
            <c:numRef>
              <c:f>Sheet2!$A$2:$A$22</c:f>
              <c:numCache>
                <c:formatCode>General</c:formatCode>
                <c:ptCount val="21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  <c:pt idx="6">
                  <c:v>120</c:v>
                </c:pt>
                <c:pt idx="7">
                  <c:v>140</c:v>
                </c:pt>
                <c:pt idx="8">
                  <c:v>160</c:v>
                </c:pt>
                <c:pt idx="9">
                  <c:v>180</c:v>
                </c:pt>
                <c:pt idx="10">
                  <c:v>200</c:v>
                </c:pt>
                <c:pt idx="11">
                  <c:v>220</c:v>
                </c:pt>
                <c:pt idx="12">
                  <c:v>240</c:v>
                </c:pt>
                <c:pt idx="13">
                  <c:v>260</c:v>
                </c:pt>
                <c:pt idx="14">
                  <c:v>280</c:v>
                </c:pt>
                <c:pt idx="15">
                  <c:v>300</c:v>
                </c:pt>
                <c:pt idx="16">
                  <c:v>320</c:v>
                </c:pt>
                <c:pt idx="17">
                  <c:v>340</c:v>
                </c:pt>
                <c:pt idx="18">
                  <c:v>360</c:v>
                </c:pt>
                <c:pt idx="19">
                  <c:v>380</c:v>
                </c:pt>
                <c:pt idx="20">
                  <c:v>39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D25-48FD-BAFD-A0DEE9F8F7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08912"/>
        <c:axId val="6610480"/>
      </c:scatterChart>
      <c:valAx>
        <c:axId val="6608912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_);[Red]\(0.0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610480"/>
        <c:crosses val="autoZero"/>
        <c:crossBetween val="midCat"/>
      </c:valAx>
      <c:valAx>
        <c:axId val="6610480"/>
        <c:scaling>
          <c:orientation val="maxMin"/>
          <c:max val="4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6089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792084404414835"/>
          <c:y val="9.2112900369940076E-2"/>
          <c:w val="0.70952221783786473"/>
          <c:h val="0.86780315691032972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xVal>
            <c:numRef>
              <c:f>Sheet2!$H$2:$H$22</c:f>
              <c:numCache>
                <c:formatCode>General</c:formatCode>
                <c:ptCount val="21"/>
                <c:pt idx="0">
                  <c:v>64.099999999999994</c:v>
                </c:pt>
                <c:pt idx="1">
                  <c:v>63.62</c:v>
                </c:pt>
                <c:pt idx="2">
                  <c:v>65.77</c:v>
                </c:pt>
                <c:pt idx="3">
                  <c:v>64.81</c:v>
                </c:pt>
                <c:pt idx="4">
                  <c:v>64.92</c:v>
                </c:pt>
                <c:pt idx="5">
                  <c:v>56.81</c:v>
                </c:pt>
                <c:pt idx="6">
                  <c:v>49.88</c:v>
                </c:pt>
                <c:pt idx="7" formatCode="0.00_ ">
                  <c:v>32.880396931752131</c:v>
                </c:pt>
                <c:pt idx="8">
                  <c:v>30.92</c:v>
                </c:pt>
                <c:pt idx="9">
                  <c:v>30.83</c:v>
                </c:pt>
                <c:pt idx="10">
                  <c:v>29.19</c:v>
                </c:pt>
                <c:pt idx="11">
                  <c:v>33.200000000000003</c:v>
                </c:pt>
                <c:pt idx="12">
                  <c:v>30.35</c:v>
                </c:pt>
                <c:pt idx="13">
                  <c:v>31.57</c:v>
                </c:pt>
                <c:pt idx="14">
                  <c:v>30.93</c:v>
                </c:pt>
                <c:pt idx="15">
                  <c:v>27.62</c:v>
                </c:pt>
                <c:pt idx="16" formatCode="0.00_ ">
                  <c:v>32.760160492773224</c:v>
                </c:pt>
                <c:pt idx="17">
                  <c:v>31.62</c:v>
                </c:pt>
                <c:pt idx="18">
                  <c:v>29.81</c:v>
                </c:pt>
                <c:pt idx="19">
                  <c:v>50.58</c:v>
                </c:pt>
                <c:pt idx="20">
                  <c:v>35.97</c:v>
                </c:pt>
              </c:numCache>
            </c:numRef>
          </c:xVal>
          <c:yVal>
            <c:numRef>
              <c:f>Sheet2!$A$2:$A$22</c:f>
              <c:numCache>
                <c:formatCode>General</c:formatCode>
                <c:ptCount val="21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  <c:pt idx="6">
                  <c:v>120</c:v>
                </c:pt>
                <c:pt idx="7">
                  <c:v>140</c:v>
                </c:pt>
                <c:pt idx="8">
                  <c:v>160</c:v>
                </c:pt>
                <c:pt idx="9">
                  <c:v>180</c:v>
                </c:pt>
                <c:pt idx="10">
                  <c:v>200</c:v>
                </c:pt>
                <c:pt idx="11">
                  <c:v>220</c:v>
                </c:pt>
                <c:pt idx="12">
                  <c:v>240</c:v>
                </c:pt>
                <c:pt idx="13">
                  <c:v>260</c:v>
                </c:pt>
                <c:pt idx="14">
                  <c:v>280</c:v>
                </c:pt>
                <c:pt idx="15">
                  <c:v>300</c:v>
                </c:pt>
                <c:pt idx="16">
                  <c:v>320</c:v>
                </c:pt>
                <c:pt idx="17">
                  <c:v>340</c:v>
                </c:pt>
                <c:pt idx="18">
                  <c:v>360</c:v>
                </c:pt>
                <c:pt idx="19">
                  <c:v>380</c:v>
                </c:pt>
                <c:pt idx="20">
                  <c:v>39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761-423F-8667-F24F5A0C55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06560"/>
        <c:axId val="6609304"/>
      </c:scatterChart>
      <c:valAx>
        <c:axId val="6606560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609304"/>
        <c:crosses val="autoZero"/>
        <c:crossBetween val="midCat"/>
      </c:valAx>
      <c:valAx>
        <c:axId val="6609304"/>
        <c:scaling>
          <c:orientation val="maxMin"/>
          <c:max val="4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60656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xVal>
            <c:numRef>
              <c:f>Sheet2!$N$2:$N$22</c:f>
              <c:numCache>
                <c:formatCode>General</c:formatCode>
                <c:ptCount val="21"/>
                <c:pt idx="0">
                  <c:v>31.869999999999997</c:v>
                </c:pt>
                <c:pt idx="1">
                  <c:v>32.92</c:v>
                </c:pt>
                <c:pt idx="2">
                  <c:v>27.07</c:v>
                </c:pt>
                <c:pt idx="3">
                  <c:v>31.03</c:v>
                </c:pt>
                <c:pt idx="4">
                  <c:v>26.24</c:v>
                </c:pt>
                <c:pt idx="5">
                  <c:v>29.58</c:v>
                </c:pt>
                <c:pt idx="6">
                  <c:v>31.59</c:v>
                </c:pt>
                <c:pt idx="7">
                  <c:v>45.290000000000006</c:v>
                </c:pt>
                <c:pt idx="8">
                  <c:v>40.599999999999994</c:v>
                </c:pt>
                <c:pt idx="9">
                  <c:v>46.67</c:v>
                </c:pt>
                <c:pt idx="10">
                  <c:v>47.33</c:v>
                </c:pt>
                <c:pt idx="11">
                  <c:v>43.63</c:v>
                </c:pt>
                <c:pt idx="12">
                  <c:v>44.1</c:v>
                </c:pt>
                <c:pt idx="13">
                  <c:v>54.339999999999996</c:v>
                </c:pt>
                <c:pt idx="14">
                  <c:v>49.629999999999995</c:v>
                </c:pt>
                <c:pt idx="15">
                  <c:v>61.980000000000004</c:v>
                </c:pt>
                <c:pt idx="16">
                  <c:v>39.799999999999997</c:v>
                </c:pt>
                <c:pt idx="17">
                  <c:v>63.370000000000005</c:v>
                </c:pt>
                <c:pt idx="18">
                  <c:v>52</c:v>
                </c:pt>
                <c:pt idx="19">
                  <c:v>25.29</c:v>
                </c:pt>
                <c:pt idx="20">
                  <c:v>38.81</c:v>
                </c:pt>
              </c:numCache>
            </c:numRef>
          </c:xVal>
          <c:yVal>
            <c:numRef>
              <c:f>Sheet2!$A$2:$A$22</c:f>
              <c:numCache>
                <c:formatCode>General</c:formatCode>
                <c:ptCount val="21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  <c:pt idx="6">
                  <c:v>120</c:v>
                </c:pt>
                <c:pt idx="7">
                  <c:v>140</c:v>
                </c:pt>
                <c:pt idx="8">
                  <c:v>160</c:v>
                </c:pt>
                <c:pt idx="9">
                  <c:v>180</c:v>
                </c:pt>
                <c:pt idx="10">
                  <c:v>200</c:v>
                </c:pt>
                <c:pt idx="11">
                  <c:v>220</c:v>
                </c:pt>
                <c:pt idx="12">
                  <c:v>240</c:v>
                </c:pt>
                <c:pt idx="13">
                  <c:v>260</c:v>
                </c:pt>
                <c:pt idx="14">
                  <c:v>280</c:v>
                </c:pt>
                <c:pt idx="15">
                  <c:v>300</c:v>
                </c:pt>
                <c:pt idx="16">
                  <c:v>320</c:v>
                </c:pt>
                <c:pt idx="17">
                  <c:v>340</c:v>
                </c:pt>
                <c:pt idx="18">
                  <c:v>360</c:v>
                </c:pt>
                <c:pt idx="19">
                  <c:v>380</c:v>
                </c:pt>
                <c:pt idx="20">
                  <c:v>39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136F-4497-9B4B-2711EAAC3F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10872"/>
        <c:axId val="6611264"/>
      </c:scatterChart>
      <c:valAx>
        <c:axId val="6610872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611264"/>
        <c:crosses val="autoZero"/>
        <c:crossBetween val="midCat"/>
      </c:valAx>
      <c:valAx>
        <c:axId val="6611264"/>
        <c:scaling>
          <c:orientation val="maxMin"/>
          <c:max val="4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6108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891284-2D87-4E43-9E42-848A7FAE64D1}" type="datetimeFigureOut">
              <a:rPr lang="ko-KR" altLang="en-US" smtClean="0"/>
              <a:t>2018-11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0CD9BB-B495-4C85-A1CC-D86A9F0465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69858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EC66-D8E1-4E7B-8BD8-50DB6DCFC9ED}" type="datetimeFigureOut">
              <a:rPr lang="ko-KR" altLang="en-US" smtClean="0"/>
              <a:t>2018-1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E13D7-7B2C-4B56-A884-3D7498CAA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2938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EC66-D8E1-4E7B-8BD8-50DB6DCFC9ED}" type="datetimeFigureOut">
              <a:rPr lang="ko-KR" altLang="en-US" smtClean="0"/>
              <a:t>2018-1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E13D7-7B2C-4B56-A884-3D7498CAA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3860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EC66-D8E1-4E7B-8BD8-50DB6DCFC9ED}" type="datetimeFigureOut">
              <a:rPr lang="ko-KR" altLang="en-US" smtClean="0"/>
              <a:t>2018-1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E13D7-7B2C-4B56-A884-3D7498CAA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7691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EC66-D8E1-4E7B-8BD8-50DB6DCFC9ED}" type="datetimeFigureOut">
              <a:rPr lang="ko-KR" altLang="en-US" smtClean="0"/>
              <a:t>2018-1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E13D7-7B2C-4B56-A884-3D7498CAA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5055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EC66-D8E1-4E7B-8BD8-50DB6DCFC9ED}" type="datetimeFigureOut">
              <a:rPr lang="ko-KR" altLang="en-US" smtClean="0"/>
              <a:t>2018-1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E13D7-7B2C-4B56-A884-3D7498CAA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0175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EC66-D8E1-4E7B-8BD8-50DB6DCFC9ED}" type="datetimeFigureOut">
              <a:rPr lang="ko-KR" altLang="en-US" smtClean="0"/>
              <a:t>2018-1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E13D7-7B2C-4B56-A884-3D7498CAA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2505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EC66-D8E1-4E7B-8BD8-50DB6DCFC9ED}" type="datetimeFigureOut">
              <a:rPr lang="ko-KR" altLang="en-US" smtClean="0"/>
              <a:t>2018-11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E13D7-7B2C-4B56-A884-3D7498CAA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6238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EC66-D8E1-4E7B-8BD8-50DB6DCFC9ED}" type="datetimeFigureOut">
              <a:rPr lang="ko-KR" altLang="en-US" smtClean="0"/>
              <a:t>2018-11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E13D7-7B2C-4B56-A884-3D7498CAA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2885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EC66-D8E1-4E7B-8BD8-50DB6DCFC9ED}" type="datetimeFigureOut">
              <a:rPr lang="ko-KR" altLang="en-US" smtClean="0"/>
              <a:t>2018-11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E13D7-7B2C-4B56-A884-3D7498CAA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7247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EC66-D8E1-4E7B-8BD8-50DB6DCFC9ED}" type="datetimeFigureOut">
              <a:rPr lang="ko-KR" altLang="en-US" smtClean="0"/>
              <a:t>2018-1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E13D7-7B2C-4B56-A884-3D7498CAA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7271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EC66-D8E1-4E7B-8BD8-50DB6DCFC9ED}" type="datetimeFigureOut">
              <a:rPr lang="ko-KR" altLang="en-US" smtClean="0"/>
              <a:t>2018-1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E13D7-7B2C-4B56-A884-3D7498CAA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7568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6EC66-D8E1-4E7B-8BD8-50DB6DCFC9ED}" type="datetimeFigureOut">
              <a:rPr lang="ko-KR" altLang="en-US" smtClean="0"/>
              <a:t>2018-1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8E13D7-7B2C-4B56-A884-3D7498CAA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2575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그룹 16"/>
          <p:cNvGrpSpPr/>
          <p:nvPr/>
        </p:nvGrpSpPr>
        <p:grpSpPr>
          <a:xfrm>
            <a:off x="98450" y="719662"/>
            <a:ext cx="9582094" cy="3676158"/>
            <a:chOff x="98450" y="719662"/>
            <a:chExt cx="9582094" cy="3676158"/>
          </a:xfrm>
        </p:grpSpPr>
        <p:sp>
          <p:nvSpPr>
            <p:cNvPr id="16" name="직사각형 15"/>
            <p:cNvSpPr/>
            <p:nvPr/>
          </p:nvSpPr>
          <p:spPr>
            <a:xfrm>
              <a:off x="644240" y="1586673"/>
              <a:ext cx="7744183" cy="77131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grpSp>
          <p:nvGrpSpPr>
            <p:cNvPr id="3" name="그룹 2"/>
            <p:cNvGrpSpPr/>
            <p:nvPr/>
          </p:nvGrpSpPr>
          <p:grpSpPr>
            <a:xfrm>
              <a:off x="98450" y="719662"/>
              <a:ext cx="9582094" cy="3676158"/>
              <a:chOff x="382618" y="694611"/>
              <a:chExt cx="9582094" cy="3676158"/>
            </a:xfrm>
          </p:grpSpPr>
          <p:graphicFrame>
            <p:nvGraphicFramePr>
              <p:cNvPr id="5" name="차트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68740457"/>
                  </p:ext>
                </p:extLst>
              </p:nvPr>
            </p:nvGraphicFramePr>
            <p:xfrm>
              <a:off x="687468" y="694611"/>
              <a:ext cx="1916839" cy="367615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6" name="차트 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98296564"/>
                  </p:ext>
                </p:extLst>
              </p:nvPr>
            </p:nvGraphicFramePr>
            <p:xfrm>
              <a:off x="2574179" y="1178251"/>
              <a:ext cx="2004565" cy="311484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7" name="차트 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1732205"/>
                  </p:ext>
                </p:extLst>
              </p:nvPr>
            </p:nvGraphicFramePr>
            <p:xfrm>
              <a:off x="4478564" y="1178251"/>
              <a:ext cx="2088232" cy="316835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8" name="차트 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27403311"/>
                  </p:ext>
                </p:extLst>
              </p:nvPr>
            </p:nvGraphicFramePr>
            <p:xfrm>
              <a:off x="6530024" y="1181286"/>
              <a:ext cx="2170761" cy="316835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2" name="TextBox 1"/>
              <p:cNvSpPr txBox="1"/>
              <p:nvPr/>
            </p:nvSpPr>
            <p:spPr>
              <a:xfrm>
                <a:off x="827584" y="869464"/>
                <a:ext cx="244827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otal Nitrogen (wt.%)</a:t>
                </a:r>
                <a:endParaRPr lang="ko-KR" altLang="en-US" sz="105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699792" y="869464"/>
                <a:ext cx="32232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otal Organic Carbon (wt.%)</a:t>
                </a:r>
                <a:endParaRPr lang="ko-KR" altLang="en-US" sz="105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786616" y="869464"/>
                <a:ext cx="32232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ater Contents (wt.%)</a:t>
                </a:r>
                <a:endParaRPr lang="ko-KR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6741462" y="869464"/>
                <a:ext cx="32232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rain size distribution (wt.%)</a:t>
                </a:r>
                <a:endParaRPr lang="ko-KR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6200000">
                <a:off x="-11180" y="2341075"/>
                <a:ext cx="1041511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epth (</a:t>
                </a:r>
                <a:r>
                  <a:rPr lang="en-US" altLang="ko-KR" sz="105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mbsf</a:t>
                </a:r>
                <a:r>
                  <a:rPr lang="en-US" altLang="ko-KR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4" name="직사각형 3"/>
          <p:cNvSpPr/>
          <p:nvPr/>
        </p:nvSpPr>
        <p:spPr>
          <a:xfrm>
            <a:off x="179512" y="95492"/>
            <a:ext cx="11277464" cy="4570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ko-KR" sz="14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Physicochemical profiles along the depth of the sampled core.</a:t>
            </a:r>
            <a:endParaRPr lang="ko-KR" altLang="ko-KR" sz="1050" kern="10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52571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269937" y="14399"/>
            <a:ext cx="8334511" cy="8879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ko-KR" sz="14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ko-KR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milarities of samples based on the log-transformed relative abundance of each OTU of bacteria (A)</a:t>
            </a:r>
            <a:r>
              <a:rPr lang="en-US" altLang="ko-KR" sz="14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archaea (B).</a:t>
            </a:r>
            <a:endParaRPr lang="ko-KR" altLang="ko-KR" sz="1050" kern="10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36" name="그룹 35"/>
          <p:cNvGrpSpPr/>
          <p:nvPr/>
        </p:nvGrpSpPr>
        <p:grpSpPr>
          <a:xfrm>
            <a:off x="354015" y="1864208"/>
            <a:ext cx="8789985" cy="2935099"/>
            <a:chOff x="354015" y="1864208"/>
            <a:chExt cx="8789985" cy="2935099"/>
          </a:xfrm>
        </p:grpSpPr>
        <p:sp>
          <p:nvSpPr>
            <p:cNvPr id="5" name="TextBox 4"/>
            <p:cNvSpPr txBox="1"/>
            <p:nvPr/>
          </p:nvSpPr>
          <p:spPr>
            <a:xfrm>
              <a:off x="2460224" y="4491530"/>
              <a:ext cx="19442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epth (</a:t>
              </a:r>
              <a:r>
                <a:rPr lang="en-US" altLang="ko-KR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mbsf</a:t>
              </a:r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-167138" y="3021441"/>
              <a:ext cx="15841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milarity (%)</a:t>
              </a:r>
              <a:endParaRPr lang="ko-KR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732240" y="4491530"/>
              <a:ext cx="19442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epth (</a:t>
              </a:r>
              <a:r>
                <a:rPr lang="en-US" altLang="ko-KR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ko-KR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bsf</a:t>
              </a:r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54015" y="1864208"/>
              <a:ext cx="9776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 smtClean="0"/>
                <a:t>(A)</a:t>
              </a:r>
              <a:endParaRPr lang="ko-KR" altLang="en-US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234396" y="1902710"/>
              <a:ext cx="9776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 smtClean="0"/>
                <a:t>(B)</a:t>
              </a:r>
              <a:endParaRPr lang="ko-KR" altLang="en-US"/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4701724" y="3021441"/>
              <a:ext cx="15841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milarity (%)</a:t>
              </a:r>
              <a:endParaRPr lang="ko-KR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" name="그룹 15"/>
            <p:cNvGrpSpPr/>
            <p:nvPr/>
          </p:nvGrpSpPr>
          <p:grpSpPr>
            <a:xfrm>
              <a:off x="5723209" y="2268242"/>
              <a:ext cx="3420791" cy="2269215"/>
              <a:chOff x="5508103" y="2564904"/>
              <a:chExt cx="3503516" cy="2592288"/>
            </a:xfrm>
          </p:grpSpPr>
          <p:pic>
            <p:nvPicPr>
              <p:cNvPr id="8" name="그림 7"/>
              <p:cNvPicPr>
                <a:picLocks noChangeAspect="1"/>
              </p:cNvPicPr>
              <p:nvPr/>
            </p:nvPicPr>
            <p:blipFill rotWithShape="1">
              <a:blip r:embed="rId2"/>
              <a:srcRect l="5443" t="4347" b="5467"/>
              <a:stretch/>
            </p:blipFill>
            <p:spPr>
              <a:xfrm>
                <a:off x="5508103" y="2780928"/>
                <a:ext cx="3503515" cy="2376264"/>
              </a:xfrm>
              <a:prstGeom prst="rect">
                <a:avLst/>
              </a:prstGeom>
            </p:spPr>
          </p:pic>
          <p:sp>
            <p:nvSpPr>
              <p:cNvPr id="15" name="직사각형 14"/>
              <p:cNvSpPr/>
              <p:nvPr/>
            </p:nvSpPr>
            <p:spPr>
              <a:xfrm>
                <a:off x="7236296" y="2564904"/>
                <a:ext cx="1775323" cy="36004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23" name="그룹 22"/>
            <p:cNvGrpSpPr/>
            <p:nvPr/>
          </p:nvGrpSpPr>
          <p:grpSpPr>
            <a:xfrm>
              <a:off x="759462" y="2163478"/>
              <a:ext cx="4545935" cy="2362467"/>
              <a:chOff x="323528" y="4221088"/>
              <a:chExt cx="4741638" cy="2232248"/>
            </a:xfrm>
          </p:grpSpPr>
          <p:pic>
            <p:nvPicPr>
              <p:cNvPr id="20" name="그림 19"/>
              <p:cNvPicPr>
                <a:picLocks noChangeAspect="1"/>
              </p:cNvPicPr>
              <p:nvPr/>
            </p:nvPicPr>
            <p:blipFill rotWithShape="1">
              <a:blip r:embed="rId3"/>
              <a:srcRect l="3861" t="9833" b="4905"/>
              <a:stretch/>
            </p:blipFill>
            <p:spPr>
              <a:xfrm>
                <a:off x="323528" y="4293096"/>
                <a:ext cx="4741638" cy="2160240"/>
              </a:xfrm>
              <a:prstGeom prst="rect">
                <a:avLst/>
              </a:prstGeom>
            </p:spPr>
          </p:pic>
          <p:sp>
            <p:nvSpPr>
              <p:cNvPr id="22" name="직사각형 21"/>
              <p:cNvSpPr/>
              <p:nvPr/>
            </p:nvSpPr>
            <p:spPr>
              <a:xfrm>
                <a:off x="2733448" y="4221088"/>
                <a:ext cx="2331718" cy="1979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302361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6997097"/>
              </p:ext>
            </p:extLst>
          </p:nvPr>
        </p:nvGraphicFramePr>
        <p:xfrm>
          <a:off x="457199" y="1556792"/>
          <a:ext cx="8229602" cy="2448277"/>
        </p:xfrm>
        <a:graphic>
          <a:graphicData uri="http://schemas.openxmlformats.org/drawingml/2006/table">
            <a:tbl>
              <a:tblPr/>
              <a:tblGrid>
                <a:gridCol w="54013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4013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382598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4013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40138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540138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540138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540138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735188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750191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630161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705180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682674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562644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</a:tblGrid>
              <a:tr h="23551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 ID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epth (cmbsf)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verage </a:t>
                      </a:r>
                      <a:r>
                        <a:rPr lang="en-US" altLang="ko-KR" sz="700" baseline="30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Arial" panose="020B0604020202020204" pitchFamily="34" charset="0"/>
                        </a:rPr>
                        <a:t>ǂ</a:t>
                      </a:r>
                      <a:endParaRPr lang="en-US" altLang="ko-KR" sz="4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axonomy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3551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0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80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hylum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lass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rder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mily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enu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pecie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_OTU6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1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C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.58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B8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.93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B8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.25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.72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.61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.73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renarchaeota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CG_c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F424768_o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F424768_f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EU284653_g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M713450_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43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C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.91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B8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46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54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.99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B8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.8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.2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renarchaeota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CG_c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Q841218_o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Q363789_f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B177021_g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B177021_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0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.93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B8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2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C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.74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B8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45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2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9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21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renarchaeota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CG_c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F424768_o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Y592052_f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Y592052_g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Y592052_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9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4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C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.36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88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9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9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0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4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9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82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renarchaeota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CG_c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Q841218_o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Q841218_f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Q841218_g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EU713901_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9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C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.9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B8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5.46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4F0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9.98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B6C1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15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76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9.24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Euryarchaeot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hermoplasmat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roup3_o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BGd_f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B252425_g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Q058803_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8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9.75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1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6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5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4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C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5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Euryarchaeot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hermoplasmat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roup3_o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BGd_f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unclassified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unclassified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5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C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.4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9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4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43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53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9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65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Euryarchaeot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hermoplasmat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roup3_o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BGd_f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B252425_g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Q640158_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8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21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9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9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9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.38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74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Euryarchaeot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BGe_c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B260057_o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B329775_f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B329775_g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JQ815957_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3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3.36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1.12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5.13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5.55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8.82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9.1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okiarchaeota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BGB_c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Y835409_o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Y835411_f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Y835411_g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unclassified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.2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B8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.6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0.0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.45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.64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.49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okiarchaeota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BGB_c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Y835409_o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Y835411_f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EU731801_g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B177230_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9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4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9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8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C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25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C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6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C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.71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B8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86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okiarchaeota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BGB_c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Y835409_o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Y835411_f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Y835411_g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Y835411_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1.7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.6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B8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.49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.46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B8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8.32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.36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.0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haumarchaeota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roup1a_c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enarchaeale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enarchaeaceae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itrosopumilu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unclassified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5.76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4F0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.09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B8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.64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2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4.55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B6C1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.14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8E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9.5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haumarchaeota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roup1a_c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enarchaeale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enarchaeacea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itrosopumilu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unclassified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6.8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B6C1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84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9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8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9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5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C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5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9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9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9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.33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haumarchaeot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roup1a_c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enarchaeale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enarchaeaceae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EF069384_g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B240744_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318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_</a:t>
                      </a:r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TU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2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7 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haumarchaeot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roup1a_c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enarchaeale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enarchaeaceae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J718987_g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J487539_s</a:t>
                      </a:r>
                    </a:p>
                  </a:txBody>
                  <a:tcPr marL="7500" marR="7500" marT="75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</a:tbl>
          </a:graphicData>
        </a:graphic>
      </p:graphicFrame>
      <p:sp>
        <p:nvSpPr>
          <p:cNvPr id="3" name="직사각형 2"/>
          <p:cNvSpPr/>
          <p:nvPr/>
        </p:nvSpPr>
        <p:spPr>
          <a:xfrm>
            <a:off x="107504" y="0"/>
            <a:ext cx="892899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ko-KR" sz="14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at map and taxonomic affiliation of major archaeal OTUs of sediments along the depth of the core.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ajor OTUs ≥3% composition in at least in one sample were selected. The color gradient from white to brown indicates low to high relative abundance values. </a:t>
            </a:r>
            <a:r>
              <a:rPr lang="en-US" altLang="ko-KR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ǂ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enotes the mean relative abundance of each OTU in sediments of all depths.</a:t>
            </a:r>
            <a:endParaRPr lang="ko-KR" altLang="ko-KR" sz="1050" kern="10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11489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29" b="62600"/>
          <a:stretch/>
        </p:blipFill>
        <p:spPr>
          <a:xfrm>
            <a:off x="1638499" y="1924084"/>
            <a:ext cx="6533901" cy="5157192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7544" y="175573"/>
            <a:ext cx="8046640" cy="15132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ko-KR" sz="14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Incomplete Wood-</a:t>
            </a:r>
            <a:r>
              <a:rPr lang="en-US" altLang="ko-KR" sz="1400" b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jungdahl</a:t>
            </a:r>
            <a:r>
              <a:rPr lang="en-US" altLang="ko-KR" sz="14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hway recovered from RS JS1-cSAG. </a:t>
            </a:r>
            <a:endParaRPr lang="en-US" altLang="ko-KR" sz="1400" b="1" kern="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ko-KR" sz="14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encoding carbon monoxide dehydrogenase </a:t>
            </a:r>
            <a:r>
              <a:rPr lang="en-US" altLang="ko-KR" sz="14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acetyl-CoA </a:t>
            </a:r>
            <a:r>
              <a:rPr lang="en-US" altLang="ko-KR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thase were missing from the RS JS1-cSAG.</a:t>
            </a:r>
            <a:endParaRPr lang="ko-KR" altLang="ko-KR" sz="105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2700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60</TotalTime>
  <Words>406</Words>
  <Application>Microsoft Office PowerPoint</Application>
  <PresentationFormat>화면 슬라이드 쇼(4:3)</PresentationFormat>
  <Paragraphs>242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MS Mincho</vt:lpstr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영미</dc:creator>
  <cp:lastModifiedBy>이 영미</cp:lastModifiedBy>
  <cp:revision>139</cp:revision>
  <dcterms:created xsi:type="dcterms:W3CDTF">2015-12-16T06:04:09Z</dcterms:created>
  <dcterms:modified xsi:type="dcterms:W3CDTF">2018-11-12T01:29:47Z</dcterms:modified>
</cp:coreProperties>
</file>